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5BFF1E-6137-4FA0-A4FA-E73C95BC2E7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2317E2-4D50-4E0C-94C2-4AB22DE48AA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43257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T. TEXANA (clave 2 IBAÑES)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coides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l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agelómero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 insertados en diferentes niveles sobrepasando el extremo apical del artejo; ala aproximadamente 3 veces más larga que su anchura máxima;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ámero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n corvadura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rsobasal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y ápice sencillo, con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rdas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mples desde su mitad apical, tan largo como la 6ta parte de la longitud del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onocoxito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Este último sin mechón basal. Lóbulo lateral largo, delgado, apenas sobrepasando la longitud del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onocoxito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odema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aculadores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binado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MX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</a:t>
            </a:r>
            <a:r>
              <a:rPr lang="es-MX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bañez</a:t>
            </a:r>
            <a:r>
              <a:rPr lang="es-MX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Bernal,</a:t>
            </a:r>
            <a:r>
              <a:rPr lang="es-MX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02) = </a:t>
            </a:r>
            <a:r>
              <a:rPr lang="es-MX" dirty="0" smtClean="0"/>
              <a:t>PHLEBOTOMINAE (DIPTERA: PSYCHODIDAE) DE MÉXICO. III. LAS ESPECIES DE LUTZOMYIA ( PSATHYROMYIA) BARRETTO, DEL GRUPO ARAGOI, DE L. (TRICHOPYGOMYIA) BARRETTO, DEL GRUPO DREISBACHI Y DE L. </a:t>
            </a:r>
            <a:r>
              <a:rPr lang="es-MX" smtClean="0"/>
              <a:t>(NYSSOMYIA) BARRETTO</a:t>
            </a:r>
            <a:endParaRPr lang="es-MX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5A858A-464D-4385-82EC-A2D835818226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75324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7542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00446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33590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74799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50328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20484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17148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49652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51997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05852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82296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0FA82-464A-485F-A612-3457F118E140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E2F62-7643-4FFE-8785-E4F26CD5FD8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0635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51" t="37811" r="19652" b="26965"/>
          <a:stretch/>
        </p:blipFill>
        <p:spPr>
          <a:xfrm>
            <a:off x="900655" y="4559746"/>
            <a:ext cx="5114399" cy="1459154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67" t="9751" r="46983" b="26567"/>
          <a:stretch/>
        </p:blipFill>
        <p:spPr>
          <a:xfrm rot="5400000">
            <a:off x="8066366" y="2550994"/>
            <a:ext cx="1483503" cy="5452309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18" r="4220"/>
          <a:stretch/>
        </p:blipFill>
        <p:spPr>
          <a:xfrm>
            <a:off x="900655" y="40332"/>
            <a:ext cx="5130441" cy="4462359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6941300" y="140692"/>
            <a:ext cx="694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400" b="1" dirty="0"/>
              <a:t>B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6143054" y="4476989"/>
            <a:ext cx="694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400" b="1" dirty="0"/>
              <a:t>E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10902370" y="167243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R2</a:t>
            </a:r>
            <a:endParaRPr lang="es-MX" dirty="0"/>
          </a:p>
        </p:txBody>
      </p:sp>
      <p:sp>
        <p:nvSpPr>
          <p:cNvPr id="13" name="CuadroTexto 12"/>
          <p:cNvSpPr txBox="1"/>
          <p:nvPr/>
        </p:nvSpPr>
        <p:spPr>
          <a:xfrm>
            <a:off x="9876599" y="93530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R1</a:t>
            </a:r>
            <a:endParaRPr lang="es-MX" dirty="0"/>
          </a:p>
        </p:txBody>
      </p:sp>
      <p:grpSp>
        <p:nvGrpSpPr>
          <p:cNvPr id="21" name="Grupo 20"/>
          <p:cNvGrpSpPr/>
          <p:nvPr/>
        </p:nvGrpSpPr>
        <p:grpSpPr>
          <a:xfrm>
            <a:off x="6081966" y="1696273"/>
            <a:ext cx="5452307" cy="2790377"/>
            <a:chOff x="6784053" y="1737249"/>
            <a:chExt cx="5130441" cy="2671999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462" b="17452"/>
            <a:stretch/>
          </p:blipFill>
          <p:spPr>
            <a:xfrm>
              <a:off x="6784053" y="1786734"/>
              <a:ext cx="5130441" cy="2622514"/>
            </a:xfrm>
            <a:prstGeom prst="rect">
              <a:avLst/>
            </a:prstGeom>
          </p:spPr>
        </p:pic>
        <p:sp>
          <p:nvSpPr>
            <p:cNvPr id="15" name="CuadroTexto 14"/>
            <p:cNvSpPr txBox="1"/>
            <p:nvPr/>
          </p:nvSpPr>
          <p:spPr>
            <a:xfrm>
              <a:off x="9949333" y="3295086"/>
              <a:ext cx="953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dirty="0" smtClean="0"/>
                <a:t>PR</a:t>
              </a:r>
              <a:endParaRPr lang="es-MX" dirty="0"/>
            </a:p>
          </p:txBody>
        </p:sp>
        <p:sp>
          <p:nvSpPr>
            <p:cNvPr id="16" name="CuadroTexto 15"/>
            <p:cNvSpPr txBox="1"/>
            <p:nvPr/>
          </p:nvSpPr>
          <p:spPr>
            <a:xfrm>
              <a:off x="9075471" y="2095861"/>
              <a:ext cx="953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dirty="0" smtClean="0"/>
                <a:t>GT</a:t>
              </a:r>
              <a:endParaRPr lang="es-MX" dirty="0"/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10058489" y="1737249"/>
              <a:ext cx="953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dirty="0" smtClean="0"/>
                <a:t>GL</a:t>
              </a:r>
              <a:endParaRPr lang="es-MX" dirty="0"/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10667790" y="3741820"/>
              <a:ext cx="953037" cy="353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dirty="0" smtClean="0"/>
                <a:t>LL</a:t>
              </a:r>
              <a:endParaRPr lang="es-MX" dirty="0"/>
            </a:p>
          </p:txBody>
        </p:sp>
      </p:grpSp>
      <p:pic>
        <p:nvPicPr>
          <p:cNvPr id="22" name="Imagen 2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1966" y="42227"/>
            <a:ext cx="5452307" cy="1666875"/>
          </a:xfrm>
          <a:prstGeom prst="rect">
            <a:avLst/>
          </a:prstGeom>
        </p:spPr>
      </p:pic>
      <p:sp>
        <p:nvSpPr>
          <p:cNvPr id="23" name="CuadroTexto 22"/>
          <p:cNvSpPr txBox="1"/>
          <p:nvPr/>
        </p:nvSpPr>
        <p:spPr>
          <a:xfrm>
            <a:off x="1028654" y="59087"/>
            <a:ext cx="694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400" b="1" dirty="0" smtClean="0"/>
              <a:t>A</a:t>
            </a:r>
            <a:endParaRPr lang="es-MX" sz="2400" b="1" dirty="0"/>
          </a:p>
        </p:txBody>
      </p:sp>
      <p:sp>
        <p:nvSpPr>
          <p:cNvPr id="24" name="CuadroTexto 23"/>
          <p:cNvSpPr txBox="1"/>
          <p:nvPr/>
        </p:nvSpPr>
        <p:spPr>
          <a:xfrm>
            <a:off x="1028655" y="4486650"/>
            <a:ext cx="694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400" b="1" dirty="0"/>
              <a:t>B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6139125" y="-44364"/>
            <a:ext cx="694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400" b="1" dirty="0" smtClean="0"/>
              <a:t>C</a:t>
            </a:r>
            <a:endParaRPr lang="es-MX" sz="2400" b="1" dirty="0"/>
          </a:p>
        </p:txBody>
      </p:sp>
      <p:sp>
        <p:nvSpPr>
          <p:cNvPr id="26" name="CuadroTexto 25"/>
          <p:cNvSpPr txBox="1"/>
          <p:nvPr/>
        </p:nvSpPr>
        <p:spPr>
          <a:xfrm>
            <a:off x="6133825" y="1704113"/>
            <a:ext cx="694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400" b="1" dirty="0"/>
              <a:t>D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3830462" y="4480234"/>
            <a:ext cx="4632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dirty="0" smtClean="0"/>
              <a:t>R1</a:t>
            </a:r>
            <a:endParaRPr lang="es-MX" sz="1400" dirty="0"/>
          </a:p>
        </p:txBody>
      </p:sp>
      <p:sp>
        <p:nvSpPr>
          <p:cNvPr id="28" name="CuadroTexto 27"/>
          <p:cNvSpPr txBox="1"/>
          <p:nvPr/>
        </p:nvSpPr>
        <p:spPr>
          <a:xfrm>
            <a:off x="4882204" y="4493486"/>
            <a:ext cx="4352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dirty="0" smtClean="0"/>
              <a:t>R2</a:t>
            </a:r>
            <a:endParaRPr lang="es-MX" sz="1400" dirty="0"/>
          </a:p>
        </p:txBody>
      </p:sp>
      <p:sp>
        <p:nvSpPr>
          <p:cNvPr id="29" name="CuadroTexto 28"/>
          <p:cNvSpPr txBox="1"/>
          <p:nvPr/>
        </p:nvSpPr>
        <p:spPr>
          <a:xfrm>
            <a:off x="5397588" y="4691270"/>
            <a:ext cx="4553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dirty="0" smtClean="0"/>
              <a:t>R3</a:t>
            </a:r>
            <a:endParaRPr lang="es-MX" sz="1400" dirty="0"/>
          </a:p>
        </p:txBody>
      </p:sp>
      <p:sp>
        <p:nvSpPr>
          <p:cNvPr id="30" name="CuadroTexto 29"/>
          <p:cNvSpPr txBox="1"/>
          <p:nvPr/>
        </p:nvSpPr>
        <p:spPr>
          <a:xfrm>
            <a:off x="9732836" y="1297560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AS</a:t>
            </a:r>
            <a:endParaRPr lang="es-MX" dirty="0"/>
          </a:p>
        </p:txBody>
      </p:sp>
      <p:sp>
        <p:nvSpPr>
          <p:cNvPr id="31" name="CuadroTexto 30"/>
          <p:cNvSpPr txBox="1"/>
          <p:nvPr/>
        </p:nvSpPr>
        <p:spPr>
          <a:xfrm>
            <a:off x="9591723" y="64515"/>
            <a:ext cx="953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AS</a:t>
            </a:r>
            <a:endParaRPr lang="es-MX" dirty="0"/>
          </a:p>
        </p:txBody>
      </p:sp>
      <p:sp>
        <p:nvSpPr>
          <p:cNvPr id="32" name="CuadroTexto 31"/>
          <p:cNvSpPr txBox="1"/>
          <p:nvPr/>
        </p:nvSpPr>
        <p:spPr>
          <a:xfrm>
            <a:off x="6941300" y="5197842"/>
            <a:ext cx="1012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AP</a:t>
            </a:r>
            <a:endParaRPr lang="es-MX" dirty="0"/>
          </a:p>
        </p:txBody>
      </p:sp>
      <p:sp>
        <p:nvSpPr>
          <p:cNvPr id="33" name="CuadroTexto 32"/>
          <p:cNvSpPr txBox="1"/>
          <p:nvPr/>
        </p:nvSpPr>
        <p:spPr>
          <a:xfrm>
            <a:off x="7954127" y="5567174"/>
            <a:ext cx="1012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BM</a:t>
            </a:r>
            <a:endParaRPr lang="es-MX" dirty="0"/>
          </a:p>
        </p:txBody>
      </p:sp>
      <p:sp>
        <p:nvSpPr>
          <p:cNvPr id="34" name="CuadroTexto 33"/>
          <p:cNvSpPr txBox="1"/>
          <p:nvPr/>
        </p:nvSpPr>
        <p:spPr>
          <a:xfrm>
            <a:off x="9237786" y="5092828"/>
            <a:ext cx="1012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FM</a:t>
            </a:r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3702116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927651" y="3357207"/>
            <a:ext cx="105089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7</a:t>
            </a:r>
            <a:r>
              <a:rPr lang="es-MX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r>
              <a:rPr lang="es-MX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MX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athyromyia</a:t>
            </a:r>
            <a:r>
              <a:rPr lang="es-MX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MX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atinella</a:t>
            </a:r>
            <a:r>
              <a:rPr lang="es-MX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MX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xana.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ew</a:t>
            </a:r>
            <a:r>
              <a:rPr lang="es-MX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g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gellomere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.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)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italia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)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jaculatory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ct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1-3: </a:t>
            </a:r>
            <a:r>
              <a:rPr lang="es-MX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ial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ins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: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coids</a:t>
            </a:r>
            <a:r>
              <a:rPr lang="es-MX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T: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onocoxite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GL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onostyle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: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mere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LL: lateral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be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: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dema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: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mb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M: </a:t>
            </a:r>
            <a:r>
              <a:rPr lang="es-MX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aments</a:t>
            </a:r>
            <a:r>
              <a:rPr lang="es-MX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s-MX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s-MX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318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28</Words>
  <Application>Microsoft Office PowerPoint</Application>
  <PresentationFormat>Panorámica</PresentationFormat>
  <Paragraphs>25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José Ríos Tostado</dc:creator>
  <cp:lastModifiedBy>Juan José Ríos Tostado</cp:lastModifiedBy>
  <cp:revision>2</cp:revision>
  <dcterms:created xsi:type="dcterms:W3CDTF">2026-06-03T03:46:14Z</dcterms:created>
  <dcterms:modified xsi:type="dcterms:W3CDTF">2026-06-03T03:49:32Z</dcterms:modified>
</cp:coreProperties>
</file>